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7720FD-BCCB-4B13-A8D7-852B3225BD33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543753-5339-40CA-8BF1-F8E0E3B552F1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3129560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4339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cs-CZ" altLang="cs-CZ" smtClean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686D91D4-5221-46B2-A9E6-0037CB98A42E}" type="slidenum">
              <a:rPr lang="fr-FR" smtClean="0"/>
              <a:pPr>
                <a:defRPr/>
              </a:pPr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55908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69185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331122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16828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31045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38968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16349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970439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76607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2077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25618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0AA9FF-C4D3-4CF3-B248-F84EA978109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7C2FE2-111A-4293-AB2F-119E856FDFD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95874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ovéPole 1"/>
          <p:cNvSpPr txBox="1">
            <a:spLocks noChangeArrowheads="1"/>
          </p:cNvSpPr>
          <p:nvPr/>
        </p:nvSpPr>
        <p:spPr bwMode="auto">
          <a:xfrm>
            <a:off x="44450" y="6330950"/>
            <a:ext cx="90011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 typeface="Arial" charset="0"/>
              <a:buNone/>
            </a:pP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Additional file 2. Endogenous 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CK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content (pmol/ g fresh weight) of 17 DAS Arabidopsis </a:t>
            </a:r>
            <a:r>
              <a:rPr lang="fr-FR" altLang="cs-CZ" sz="1200" b="1" i="1">
                <a:latin typeface="Helvetica" pitchFamily="34" charset="0"/>
                <a:cs typeface="Helvetica" pitchFamily="34" charset="0"/>
              </a:rPr>
              <a:t>ipt3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 plants complemented with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SlIPT3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or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SlIPT4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and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grown on control medium. </a:t>
            </a:r>
          </a:p>
        </p:txBody>
      </p:sp>
      <p:graphicFrame>
        <p:nvGraphicFramePr>
          <p:cNvPr id="5349" name="Group 229"/>
          <p:cNvGraphicFramePr>
            <a:graphicFrameLocks noGrp="1"/>
          </p:cNvGraphicFramePr>
          <p:nvPr>
            <p:ph idx="1"/>
          </p:nvPr>
        </p:nvGraphicFramePr>
        <p:xfrm>
          <a:off x="611188" y="404813"/>
          <a:ext cx="7921625" cy="5792796"/>
        </p:xfrm>
        <a:graphic>
          <a:graphicData uri="http://schemas.openxmlformats.org/drawingml/2006/table">
            <a:tbl>
              <a:tblPr/>
              <a:tblGrid>
                <a:gridCol w="1027112"/>
                <a:gridCol w="1101725"/>
                <a:gridCol w="1027113"/>
                <a:gridCol w="1152525"/>
                <a:gridCol w="1289050"/>
                <a:gridCol w="1154112"/>
                <a:gridCol w="1169988"/>
              </a:tblGrid>
              <a:tr h="30479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K metabolite</a:t>
                      </a:r>
                      <a:endParaRPr kumimoji="0" lang="cs-CZ" altLang="cs-CZ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475" marR="8475" marT="8476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W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2" marR="8082" marT="8083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t3 KO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2" marR="8082" marT="8083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A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2" marR="8082" marT="8083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A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2" marR="8082" marT="8083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9A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2" marR="8082" marT="8083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0A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2" marR="8082" marT="8083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27939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475" marR="8475" marT="8476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2" marR="8082" marT="8083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gridSpan="4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pmol/ g FW</a:t>
                      </a:r>
                    </a:p>
                  </a:txBody>
                  <a:tcPr marL="8082" marR="8082" marT="8083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1748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61 ± 0.2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20 ± 0.1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66 ± 0.1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35 ± 0.3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77 ± 0.3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51  ± 0.08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R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64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4 ± 0.1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6 ± 0.0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3 ± 0.03 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0 ± 0.0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2  ± 0.0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4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1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01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01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02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01 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R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4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0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3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5 ± 0.1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9 ± 0.0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4 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5 ± 0.0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71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64 ± 0.0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88 ± 0.0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81 ± 0.0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08 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R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0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61 ± 0.0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4 ± 0.0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1 ± 0.0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7 ± 0.07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69 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4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0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0 ± 0.0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1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5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6 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R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8 ±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08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8 ± 0.0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0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07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-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O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9.5 ± 1.3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9.34 ± 0.5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6.55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88 ± 0.5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7.17 ± 1.7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75  ± 0.8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RO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31 ± 0.0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92 ± 0.2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87 ± 0.0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3 ± 0.1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40 ± 0.1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28 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RO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65 ± 0.1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4 ± 0.0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7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2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6 ± 0.0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79  ± 0.1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RO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68 ± 0.0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86 ± 0.5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93 ± 0.1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98 ± 0.37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67 ± 0.3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28  ± 0.5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O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81 ± 0.1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67 ± 0.0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9 ± 0.0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8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67 ± 0.0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7  ± 0.1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7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8.55 ± 3.1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1.96 ± 1.78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8.32 ± 2.88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1.17 ± 2.2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3.29 ± 0.5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6.61  ± 2.4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9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9.66 ± 1.68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88 ± 0.2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50 ± 0.0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8.39 ± 0.8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80 ± 0.38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58  ± 0.2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7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65 ± 0.2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33 ± 0.0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08 ± 0.8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7.11 ± 0.4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6.59 ± 1.1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68  ± 0.2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Z9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9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40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6 ± 0.08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35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8 ± 0.0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2  ± 0.0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7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4.85 ± 3.4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5.48 ± 3.8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9.47 ± 6.5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8.45 ± 0.27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0.67 ± 0.9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8.82  ± 5.3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9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02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50 ± 0.0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01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02 ± 0.1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95 ± 0.1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04  ± 0.1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7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36.85 ± 19.9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2.73 ± 7.0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15.75 ± 2.4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97.47 ± 24.3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9.28 ± 8.6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65.31  ± 6.8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9G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5.33 ± 0.5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94 ± 0.17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42 ± 0.9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94 ± 0.27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31 ± 0.0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71  ± 0.4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tZRMP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98 ± 0.1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44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89 ± 0.1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29 ± 0.1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09 ± 0.0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87 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DHZRMP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7 ± 0.0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0 ± 0.0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3 ± 0.0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29 ± 0.0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18 ± 0.0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0.07  ± 0.0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cZRMP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97 ± 0.19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32 ± 0.41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1.72 ± 0.35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79 ± 0.2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50 ± 0.07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41  ± 0.60 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0796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iPRMP</a:t>
                      </a:r>
                    </a:p>
                  </a:txBody>
                  <a:tcPr marL="9525" marR="9525" marT="9526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82 ± 0.2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36 ± 0.33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4.86 ± 0.10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6.13 ± 0.82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3.18 ± 0.34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Helvetica" pitchFamily="34" charset="0"/>
                        </a:rPr>
                        <a:t>2.59  ± 0.36</a:t>
                      </a:r>
                    </a:p>
                  </a:txBody>
                  <a:tcPr marL="8082" marR="8082" marT="8083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91032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8</Words>
  <Application>Microsoft Office PowerPoint</Application>
  <PresentationFormat>Předvádění na obrazovce (4:3)</PresentationFormat>
  <Paragraphs>185</Paragraphs>
  <Slides>1</Slides>
  <Notes>1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Žižková Eva UEB</dc:creator>
  <cp:lastModifiedBy>Žižková Eva UEB</cp:lastModifiedBy>
  <cp:revision>1</cp:revision>
  <dcterms:created xsi:type="dcterms:W3CDTF">2014-10-10T16:00:13Z</dcterms:created>
  <dcterms:modified xsi:type="dcterms:W3CDTF">2014-10-10T16:00:38Z</dcterms:modified>
</cp:coreProperties>
</file>